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0" r:id="rId2"/>
  </p:sldIdLst>
  <p:sldSz cx="6858000" cy="9906000" type="A4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1AD02"/>
    <a:srgbClr val="9C770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160"/>
    <p:restoredTop sz="92955" autoAdjust="0"/>
  </p:normalViewPr>
  <p:slideViewPr>
    <p:cSldViewPr>
      <p:cViewPr varScale="1">
        <p:scale>
          <a:sx n="70" d="100"/>
          <a:sy n="70" d="100"/>
        </p:scale>
        <p:origin x="3448" y="18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5DDBB50-C5E2-4308-871B-090F5655061A}" type="datetimeFigureOut">
              <a:rPr lang="zh-TW" altLang="en-US" smtClean="0"/>
              <a:t>2020/7/19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238E3FB-C8A1-461D-A900-7A159160B77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9101790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/>
              <a:t>按一下以編輯母片副標題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3A923C-1FBF-F14D-9397-5FDB8B7398F9}" type="datetime1">
              <a:rPr lang="en-US" altLang="zh-TW" smtClean="0"/>
              <a:t>7/19/2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FBE63-B05D-49DF-9BC9-DB74F45CB0B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6919677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4559B1-1513-2F48-8E28-2B89837F9CF3}" type="datetime1">
              <a:rPr lang="en-US" altLang="zh-TW" smtClean="0"/>
              <a:t>7/19/2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FBE63-B05D-49DF-9BC9-DB74F45CB0B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0973901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D644D2-43A8-4F47-B0D1-55B57A9D055F}" type="datetime1">
              <a:rPr lang="en-US" altLang="zh-TW" smtClean="0"/>
              <a:t>7/19/2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FBE63-B05D-49DF-9BC9-DB74F45CB0B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335528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7C18E-F7AD-644B-97D3-FD833EDF550A}" type="datetime1">
              <a:rPr lang="en-US" altLang="zh-TW" smtClean="0"/>
              <a:t>7/19/2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FBE63-B05D-49DF-9BC9-DB74F45CB0B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6442161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7FA802-6D11-E343-8803-FA977093B244}" type="datetime1">
              <a:rPr lang="en-US" altLang="zh-TW" smtClean="0"/>
              <a:t>7/19/2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FBE63-B05D-49DF-9BC9-DB74F45CB0B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4784094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414AF5-7710-9B4F-BFAC-407C11B656D6}" type="datetime1">
              <a:rPr lang="en-US" altLang="zh-TW" smtClean="0"/>
              <a:t>7/19/20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FBE63-B05D-49DF-9BC9-DB74F45CB0B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2576670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BB1CDB-5EEF-0743-9707-FB36FF2FB28E}" type="datetime1">
              <a:rPr lang="en-US" altLang="zh-TW" smtClean="0"/>
              <a:t>7/19/20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FBE63-B05D-49DF-9BC9-DB74F45CB0B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0541653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D0B6FB-9827-434D-8051-5794F555E4B5}" type="datetime1">
              <a:rPr lang="en-US" altLang="zh-TW" smtClean="0"/>
              <a:t>7/19/20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FBE63-B05D-49DF-9BC9-DB74F45CB0B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37658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D3B8E0-2280-9E4E-AE84-DFE0D4EB73C1}" type="datetime1">
              <a:rPr lang="en-US" altLang="zh-TW" smtClean="0"/>
              <a:t>7/19/20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FBE63-B05D-49DF-9BC9-DB74F45CB0B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952361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D851C9-552D-6A40-B3B2-06288064F7F9}" type="datetime1">
              <a:rPr lang="en-US" altLang="zh-TW" smtClean="0"/>
              <a:t>7/19/20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FBE63-B05D-49DF-9BC9-DB74F45CB0B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423218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6AF976-54AD-5B4F-9AE9-3F4C7FC6CEC3}" type="datetime1">
              <a:rPr lang="en-US" altLang="zh-TW" smtClean="0"/>
              <a:t>7/19/20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4FBE63-B05D-49DF-9BC9-DB74F45CB0B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6156977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88906E-FB0B-214D-B629-3EA54FC31CA8}" type="datetime1">
              <a:rPr lang="en-US" altLang="zh-TW" smtClean="0"/>
              <a:t>7/19/2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4FBE63-B05D-49DF-9BC9-DB74F45CB0B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3250847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ctr" defTabSz="6858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DB314E05-3DC7-854F-B513-C5842C248A6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791" t="46577" r="9994" b="49060"/>
          <a:stretch/>
        </p:blipFill>
        <p:spPr>
          <a:xfrm>
            <a:off x="3387036" y="5294292"/>
            <a:ext cx="648072" cy="30678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8BA6567D-7F47-D64E-ABAD-DF0651AEE0B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128" r="77422" b="87954"/>
          <a:stretch/>
        </p:blipFill>
        <p:spPr>
          <a:xfrm>
            <a:off x="1817273" y="5251376"/>
            <a:ext cx="457214" cy="349696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FD538863-421B-5942-83BA-0A946E6B51C3}"/>
              </a:ext>
            </a:extLst>
          </p:cNvPr>
          <p:cNvSpPr txBox="1"/>
          <p:nvPr/>
        </p:nvSpPr>
        <p:spPr>
          <a:xfrm>
            <a:off x="2177313" y="5324073"/>
            <a:ext cx="11737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fluenza viru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F7ADD2A-6334-F14A-8131-C1FBB92B6FF2}"/>
              </a:ext>
            </a:extLst>
          </p:cNvPr>
          <p:cNvSpPr txBox="1"/>
          <p:nvPr/>
        </p:nvSpPr>
        <p:spPr>
          <a:xfrm>
            <a:off x="3789040" y="5324072"/>
            <a:ext cx="1632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Vigna radiata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xtract 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3C36ADC1-EBA9-F94C-99CB-17139DFB663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100228"/>
            <a:ext cx="6858000" cy="411480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E5EB8969-51C0-854E-8EF7-FBA767827B73}"/>
              </a:ext>
            </a:extLst>
          </p:cNvPr>
          <p:cNvSpPr txBox="1"/>
          <p:nvPr/>
        </p:nvSpPr>
        <p:spPr>
          <a:xfrm>
            <a:off x="132344" y="6105128"/>
            <a:ext cx="643737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1: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VRE potently interferes with influenza virus infection at multiple steps during the infectious cycle. </a:t>
            </a:r>
          </a:p>
        </p:txBody>
      </p:sp>
    </p:spTree>
    <p:extLst>
      <p:ext uri="{BB962C8B-B14F-4D97-AF65-F5344CB8AC3E}">
        <p14:creationId xmlns:p14="http://schemas.microsoft.com/office/powerpoint/2010/main" val="41202373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662</TotalTime>
  <Words>24</Words>
  <Application>Microsoft Macintosh PowerPoint</Application>
  <PresentationFormat>A4 Paper (210x297 mm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佈景主題</vt:lpstr>
      <vt:lpstr>PowerPoint Presentation</vt:lpstr>
    </vt:vector>
  </TitlesOfParts>
  <Company>UIT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nbuser</dc:creator>
  <cp:lastModifiedBy>Winni Chen</cp:lastModifiedBy>
  <cp:revision>362</cp:revision>
  <dcterms:created xsi:type="dcterms:W3CDTF">2018-06-22T09:24:10Z</dcterms:created>
  <dcterms:modified xsi:type="dcterms:W3CDTF">2020-07-19T01:56:59Z</dcterms:modified>
</cp:coreProperties>
</file>